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9" autoAdjust="0"/>
    <p:restoredTop sz="94660"/>
  </p:normalViewPr>
  <p:slideViewPr>
    <p:cSldViewPr snapToGrid="0">
      <p:cViewPr varScale="1">
        <p:scale>
          <a:sx n="44" d="100"/>
          <a:sy n="44" d="100"/>
        </p:scale>
        <p:origin x="864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C6BF5F-E651-463B-943D-EF93185D4C9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E9FD51E-2DF8-4588-B90C-D41AAA3D49B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8D506C-FAAB-4DDC-B792-3B9BEC0F5A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A434F9-93E3-431C-9C3A-7EC168138BCB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97147F-6FB0-4AD3-AACE-6B16DD6DEE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7D0BD9-CC1E-4E27-A714-D8DA485805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39E55-B0DC-475E-B198-6AEDDEC025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41653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D4BA00-F300-4732-B096-73A26C7A5C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B5FFEC3-BA5A-4A2D-9E5D-B083C510BC6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5C4C29-95D6-449F-A77D-F1E5CD352D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A434F9-93E3-431C-9C3A-7EC168138BCB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5EF81C-A841-491A-BFA0-342E000328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3089AC-9F8D-41BF-8BC1-F7C26572F5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39E55-B0DC-475E-B198-6AEDDEC025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80032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064EA33-782C-4DC3-9E67-351BCB3BD1A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712A6FA-AD82-487D-877F-BBCAA154841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77BD88D-3D8D-4E4C-878A-560A113EC8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A434F9-93E3-431C-9C3A-7EC168138BCB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480430-326A-418F-9476-729C54EE97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21CDC6-EA57-4319-AD31-533FB91A87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39E55-B0DC-475E-B198-6AEDDEC025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2009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F33A8B-9BFA-4ECF-8690-54C41C738F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0106D26-09AF-4945-ACAD-AF42C05072D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C88F8B-0DA1-4A90-937F-AF0519BDE6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A434F9-93E3-431C-9C3A-7EC168138BCB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1374BC-33FB-470F-8D4F-4EDCA78F72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7DDEE3-65DE-4A4D-B152-8991516E32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39E55-B0DC-475E-B198-6AEDDEC025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30976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38197C-DB5A-4495-B2A6-2C7B055A68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125B02F-C60B-4B5A-8284-9A0FCF429D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DE65DB-CF22-4937-9839-F54F2BBE99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A434F9-93E3-431C-9C3A-7EC168138BCB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B186B7-1998-4D46-B66E-02C4B2003E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461F05-90F3-434B-99D5-EBE5FB7012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39E55-B0DC-475E-B198-6AEDDEC025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2565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ED947C-6CCE-4EA7-9BCF-686203FA6F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E8B3C7E-619E-4C2E-87EB-26442078E9A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027C5E5-E74F-46E7-AEB7-9A22F0DDDD5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4CA255C-7A44-412E-AAD7-0B996EBC0F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A434F9-93E3-431C-9C3A-7EC168138BCB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E721C21-D319-4519-BB1D-7D223B8710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F0C201F-55F5-450D-A299-C307C5E214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39E55-B0DC-475E-B198-6AEDDEC025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98296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865F8E-96B5-4BBB-9E9F-86DFF46FAA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DF01388-DC96-47AB-99E2-DFFABCCD82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EE03096-CAEA-4907-A09C-F6C3E6BB15E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1C6CDF8-0BEE-40CE-9370-A22D95D4646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6462E04-BBEC-4953-BC81-42AED4EDE2F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B0777D7-AEAE-4702-8280-1C77962CB6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A434F9-93E3-431C-9C3A-7EC168138BCB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BF0E66D-65F6-44F7-912B-B4B09D86D2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9527C99-9029-4D20-AEA0-A7612DE353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39E55-B0DC-475E-B198-6AEDDEC025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66773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A77F3F-9F35-4F36-8BE5-AE516D7AA3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FC91CA0-A5C2-42AB-8869-6568E437ED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A434F9-93E3-431C-9C3A-7EC168138BCB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E91055C-2245-44B3-A0BB-2DBAB9B182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4E39849-C4AE-4B85-ADDD-DA5298537C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39E55-B0DC-475E-B198-6AEDDEC025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18957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37102D5-3178-4A46-9510-9A268AF6CD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A434F9-93E3-431C-9C3A-7EC168138BCB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A8E00E7-E3C6-4A23-A49E-BA3CB4FACB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3757EAD-D662-4EA5-8041-B4D664C90A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39E55-B0DC-475E-B198-6AEDDEC025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61605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25091C-C882-4241-B324-16FA474D0E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BB35BB3-E64A-41A9-B01C-72227B4C90A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F978B53-53E4-4400-8F45-0A58E94858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D28974D-E7A5-4D1B-936C-582D2E845E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A434F9-93E3-431C-9C3A-7EC168138BCB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DEC5FA6-B4D0-45D3-8F5C-68400FDAAC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D3876A5-3267-4172-96AD-FB760429EC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39E55-B0DC-475E-B198-6AEDDEC025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32920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678B99-57DE-4D08-8D71-25BC312431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AAF4991-9EEA-4485-9D1A-302326067C4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84A03C5-3D78-4B99-9A43-13EE9455DC5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9B6FD78-72D6-4DBE-BFF0-39ED9877A0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A434F9-93E3-431C-9C3A-7EC168138BCB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2E0A011-E364-4C6E-B52F-2192E68EC6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F9984FA-9B85-4290-8C7C-448901E57A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39E55-B0DC-475E-B198-6AEDDEC025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22348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A065E3F-7FAF-4917-80E5-B2CF5D6BD4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586C4F8-3CDF-4123-8E62-88F9E5DBB1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C4D4C8-6BC3-464C-B075-236E36403C7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A434F9-93E3-431C-9C3A-7EC168138BCB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99E91B-1341-43AF-83E9-526528E854F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A3EECA-58DB-4697-B2D4-A2E213189F7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939E55-B0DC-475E-B198-6AEDDEC025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678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BF47F364-5816-49E1-8FB2-4F39253E4D6A}"/>
              </a:ext>
            </a:extLst>
          </p:cNvPr>
          <p:cNvSpPr/>
          <p:nvPr/>
        </p:nvSpPr>
        <p:spPr>
          <a:xfrm>
            <a:off x="292512" y="297903"/>
            <a:ext cx="24182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s: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EDAAB477-B24D-4266-8DB1-C487BB8731C7}"/>
              </a:ext>
            </a:extLst>
          </p:cNvPr>
          <p:cNvSpPr/>
          <p:nvPr/>
        </p:nvSpPr>
        <p:spPr>
          <a:xfrm>
            <a:off x="1180407" y="746301"/>
            <a:ext cx="505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1: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5" name="Picture 4" descr="A picture containing meter, clock&#10;&#10;Description automatically generated">
            <a:extLst>
              <a:ext uri="{FF2B5EF4-FFF2-40B4-BE49-F238E27FC236}">
                <a16:creationId xmlns:a16="http://schemas.microsoft.com/office/drawing/2014/main" id="{527E9C41-8375-491A-97B2-B6ACE6EE2DA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76884" y="1298448"/>
            <a:ext cx="5708904" cy="2130552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28921CD0-8644-4781-9FF4-370D4E27A659}"/>
              </a:ext>
            </a:extLst>
          </p:cNvPr>
          <p:cNvSpPr/>
          <p:nvPr/>
        </p:nvSpPr>
        <p:spPr>
          <a:xfrm>
            <a:off x="1180406" y="3649117"/>
            <a:ext cx="9511039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S1: Dose titration of LPS-mediated Keap1 protein expression. 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Pilot study using Western blot to assess the effects of the indicated doses of LPS on Keap1 expression in our previously established murine 5-day bone marrow-derived monocyte model. GAPDH expression is shown as a loading control.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227801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BA22235-AC0C-4C40-98B4-567F5CD39C4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6742" y="1115633"/>
            <a:ext cx="7226392" cy="3653794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8E4B169A-5086-42C3-BAF2-979A2AD2C0FD}"/>
              </a:ext>
            </a:extLst>
          </p:cNvPr>
          <p:cNvSpPr/>
          <p:nvPr/>
        </p:nvSpPr>
        <p:spPr>
          <a:xfrm>
            <a:off x="1235825" y="4619798"/>
            <a:ext cx="10152611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2: SLD-LPS fails to induce Nrf2-regulated genes.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ranscript expression of WT macrophages treated for 5 days with either PBS, 100 </a:t>
            </a:r>
            <a:r>
              <a:rPr lang="en-US" sz="14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g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/mL LPS (SLD-LPS), or 1 µg/mL LPS (high-dose LPS) of </a:t>
            </a:r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.)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eme-oxygenase1 (</a:t>
            </a:r>
            <a:r>
              <a:rPr lang="en-US" sz="14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mox-1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</a:t>
            </a:r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.)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AD(P)H dehydrogenase reductase 1 (</a:t>
            </a:r>
            <a:r>
              <a:rPr lang="en-US" sz="14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qo1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and </a:t>
            </a:r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.) </a:t>
            </a:r>
            <a:r>
              <a:rPr lang="en-US" sz="14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talase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 Transcript analysis was done using </a:t>
            </a:r>
            <a:r>
              <a:rPr lang="en-US" sz="14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qRT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PCR and the ΔΔCT method with HPRT-1 as the house-keeping control.  Statistical analysis (ANOVA) and graphs were made using </a:t>
            </a:r>
            <a:r>
              <a:rPr lang="en-US" sz="14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raphpad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rism. ***p&lt;0.001, ****p&lt;0.0001, </a:t>
            </a:r>
            <a:r>
              <a:rPr lang="en-US" sz="14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.s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is non-significant.</a:t>
            </a:r>
            <a:endParaRPr lang="en-US" sz="14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FCF00FB1-1CDA-431B-ABAA-80A7F9F0F816}"/>
              </a:ext>
            </a:extLst>
          </p:cNvPr>
          <p:cNvSpPr/>
          <p:nvPr/>
        </p:nvSpPr>
        <p:spPr>
          <a:xfrm>
            <a:off x="1180407" y="746301"/>
            <a:ext cx="505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2: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201879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253F8802-2886-4AB3-A245-85530004139B}"/>
              </a:ext>
            </a:extLst>
          </p:cNvPr>
          <p:cNvSpPr/>
          <p:nvPr/>
        </p:nvSpPr>
        <p:spPr>
          <a:xfrm>
            <a:off x="337509" y="127774"/>
            <a:ext cx="505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3: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15288CF-230D-4517-BB1D-B2D713D6173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917" t="11765" r="22775" b="28471"/>
          <a:stretch/>
        </p:blipFill>
        <p:spPr>
          <a:xfrm>
            <a:off x="1207771" y="1379668"/>
            <a:ext cx="5895190" cy="4098663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AE6407AF-FA34-4182-8EE7-E38225078573}"/>
              </a:ext>
            </a:extLst>
          </p:cNvPr>
          <p:cNvSpPr/>
          <p:nvPr/>
        </p:nvSpPr>
        <p:spPr>
          <a:xfrm>
            <a:off x="478042" y="5688449"/>
            <a:ext cx="10152611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3: Un-modified Nrf2 Co-IP blot. 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s stated in the materials and methods, co-immunoprecipitation was performed using the Abcam IP protocol and Keap1 antibody bound to Protein G agarose beads.  After incubation with the lysate and washing, protein complexes were eluted from the beads for a total of two times using SDS buffer to produce two elution fractions.  For ease of data display, the main text Figure 3 shows just elution fraction 2, the whole cell lysate control (WCL), and the protein ladder (cropped from elution fraction 1 and designated as “mw” on the above blot).</a:t>
            </a:r>
            <a:endParaRPr lang="en-US" sz="14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0BE4B70-8AD6-493E-AF5D-18B182118BE6}"/>
              </a:ext>
            </a:extLst>
          </p:cNvPr>
          <p:cNvSpPr txBox="1"/>
          <p:nvPr/>
        </p:nvSpPr>
        <p:spPr>
          <a:xfrm>
            <a:off x="1563756" y="1071891"/>
            <a:ext cx="5963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B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B51C59A-9AFC-4222-8CB4-C33F461A456B}"/>
              </a:ext>
            </a:extLst>
          </p:cNvPr>
          <p:cNvSpPr txBox="1"/>
          <p:nvPr/>
        </p:nvSpPr>
        <p:spPr>
          <a:xfrm>
            <a:off x="1919741" y="1068521"/>
            <a:ext cx="5963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P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D473906-CE1C-4042-9EA2-2E3D8AAE1832}"/>
              </a:ext>
            </a:extLst>
          </p:cNvPr>
          <p:cNvSpPr txBox="1"/>
          <p:nvPr/>
        </p:nvSpPr>
        <p:spPr>
          <a:xfrm>
            <a:off x="2275726" y="1068638"/>
            <a:ext cx="5963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.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C9C2856-DD9F-41C4-AE8E-A1E0DD711543}"/>
              </a:ext>
            </a:extLst>
          </p:cNvPr>
          <p:cNvSpPr txBox="1"/>
          <p:nvPr/>
        </p:nvSpPr>
        <p:spPr>
          <a:xfrm>
            <a:off x="2655803" y="1071774"/>
            <a:ext cx="5963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B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95FC2FC-989D-4BCF-8154-BD497B1AC20F}"/>
              </a:ext>
            </a:extLst>
          </p:cNvPr>
          <p:cNvSpPr txBox="1"/>
          <p:nvPr/>
        </p:nvSpPr>
        <p:spPr>
          <a:xfrm>
            <a:off x="3051544" y="1068404"/>
            <a:ext cx="5963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PS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73E8D63-0961-4F60-9FD0-064823577EC6}"/>
              </a:ext>
            </a:extLst>
          </p:cNvPr>
          <p:cNvSpPr txBox="1"/>
          <p:nvPr/>
        </p:nvSpPr>
        <p:spPr>
          <a:xfrm>
            <a:off x="3420781" y="1068521"/>
            <a:ext cx="5963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.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FEEF00F-F834-4AC9-B42F-06BCD2541EF7}"/>
              </a:ext>
            </a:extLst>
          </p:cNvPr>
          <p:cNvSpPr txBox="1"/>
          <p:nvPr/>
        </p:nvSpPr>
        <p:spPr>
          <a:xfrm>
            <a:off x="3832165" y="1081806"/>
            <a:ext cx="5963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BS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1CDD469-2C21-46D5-802A-CA76308DB816}"/>
              </a:ext>
            </a:extLst>
          </p:cNvPr>
          <p:cNvSpPr txBox="1"/>
          <p:nvPr/>
        </p:nvSpPr>
        <p:spPr>
          <a:xfrm>
            <a:off x="4227906" y="1078436"/>
            <a:ext cx="5963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PS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8FC50D0-A026-49B8-AD85-9A03C3258018}"/>
              </a:ext>
            </a:extLst>
          </p:cNvPr>
          <p:cNvSpPr txBox="1"/>
          <p:nvPr/>
        </p:nvSpPr>
        <p:spPr>
          <a:xfrm>
            <a:off x="1712843" y="712129"/>
            <a:ext cx="8945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lution 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255B6E9-7384-4429-B89E-767FDB1B5178}"/>
              </a:ext>
            </a:extLst>
          </p:cNvPr>
          <p:cNvSpPr txBox="1"/>
          <p:nvPr/>
        </p:nvSpPr>
        <p:spPr>
          <a:xfrm>
            <a:off x="2818142" y="712128"/>
            <a:ext cx="8945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lution 2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8CB2A47-9630-487B-B232-15E43B63FA82}"/>
              </a:ext>
            </a:extLst>
          </p:cNvPr>
          <p:cNvSpPr txBox="1"/>
          <p:nvPr/>
        </p:nvSpPr>
        <p:spPr>
          <a:xfrm>
            <a:off x="3779157" y="712128"/>
            <a:ext cx="8945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CL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45FC6E0-2468-478E-986E-E8EBC5E51C09}"/>
              </a:ext>
            </a:extLst>
          </p:cNvPr>
          <p:cNvSpPr txBox="1"/>
          <p:nvPr/>
        </p:nvSpPr>
        <p:spPr>
          <a:xfrm>
            <a:off x="1170427" y="1050280"/>
            <a:ext cx="5963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w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0882ADDD-A1D7-40D0-8EB1-8EB26EEC325E}"/>
              </a:ext>
            </a:extLst>
          </p:cNvPr>
          <p:cNvCxnSpPr>
            <a:cxnSpLocks/>
          </p:cNvCxnSpPr>
          <p:nvPr/>
        </p:nvCxnSpPr>
        <p:spPr>
          <a:xfrm>
            <a:off x="1563756" y="1019905"/>
            <a:ext cx="110529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C269597A-C884-40AC-BF2C-C08C6094B734}"/>
              </a:ext>
            </a:extLst>
          </p:cNvPr>
          <p:cNvCxnSpPr>
            <a:cxnSpLocks/>
          </p:cNvCxnSpPr>
          <p:nvPr/>
        </p:nvCxnSpPr>
        <p:spPr>
          <a:xfrm>
            <a:off x="2712753" y="1016637"/>
            <a:ext cx="110529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41946328-6E51-42D6-9253-D83EAE6B759C}"/>
              </a:ext>
            </a:extLst>
          </p:cNvPr>
          <p:cNvCxnSpPr>
            <a:cxnSpLocks/>
          </p:cNvCxnSpPr>
          <p:nvPr/>
        </p:nvCxnSpPr>
        <p:spPr>
          <a:xfrm>
            <a:off x="3872781" y="1019905"/>
            <a:ext cx="80089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3280CBE4-5F53-41B9-A2A2-E6C10590E1FF}"/>
              </a:ext>
            </a:extLst>
          </p:cNvPr>
          <p:cNvSpPr txBox="1"/>
          <p:nvPr/>
        </p:nvSpPr>
        <p:spPr>
          <a:xfrm>
            <a:off x="7063205" y="2840216"/>
            <a:ext cx="107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IB: Nrf2</a:t>
            </a:r>
          </a:p>
        </p:txBody>
      </p: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5745B436-20B2-4B9F-A7ED-C58C715459B0}"/>
              </a:ext>
            </a:extLst>
          </p:cNvPr>
          <p:cNvCxnSpPr>
            <a:cxnSpLocks/>
          </p:cNvCxnSpPr>
          <p:nvPr/>
        </p:nvCxnSpPr>
        <p:spPr>
          <a:xfrm flipH="1" flipV="1">
            <a:off x="4824254" y="3008242"/>
            <a:ext cx="2278707" cy="1325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B6039458-0D84-4D67-ABA2-FD91B6F50124}"/>
              </a:ext>
            </a:extLst>
          </p:cNvPr>
          <p:cNvSpPr txBox="1"/>
          <p:nvPr/>
        </p:nvSpPr>
        <p:spPr>
          <a:xfrm>
            <a:off x="673285" y="2815568"/>
            <a:ext cx="6785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2AC7635-B7AA-4907-984D-4F4F45564B1E}"/>
              </a:ext>
            </a:extLst>
          </p:cNvPr>
          <p:cNvSpPr txBox="1"/>
          <p:nvPr/>
        </p:nvSpPr>
        <p:spPr>
          <a:xfrm>
            <a:off x="673284" y="3299388"/>
            <a:ext cx="6785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D301CAD9-85DA-452C-AF1A-CB8CD15A480C}"/>
              </a:ext>
            </a:extLst>
          </p:cNvPr>
          <p:cNvSpPr txBox="1"/>
          <p:nvPr/>
        </p:nvSpPr>
        <p:spPr>
          <a:xfrm>
            <a:off x="590143" y="2654005"/>
            <a:ext cx="7863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7FCBA68A-BF84-4C0D-B745-D981A6070CD3}"/>
              </a:ext>
            </a:extLst>
          </p:cNvPr>
          <p:cNvSpPr txBox="1"/>
          <p:nvPr/>
        </p:nvSpPr>
        <p:spPr>
          <a:xfrm>
            <a:off x="590143" y="2500116"/>
            <a:ext cx="7863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0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C7EE1CF1-5030-41EE-BD47-4C252DF81E65}"/>
              </a:ext>
            </a:extLst>
          </p:cNvPr>
          <p:cNvSpPr txBox="1"/>
          <p:nvPr/>
        </p:nvSpPr>
        <p:spPr>
          <a:xfrm>
            <a:off x="590143" y="2170725"/>
            <a:ext cx="7863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517DDBED-45D4-4816-BBA4-74386E14B066}"/>
              </a:ext>
            </a:extLst>
          </p:cNvPr>
          <p:cNvSpPr txBox="1"/>
          <p:nvPr/>
        </p:nvSpPr>
        <p:spPr>
          <a:xfrm>
            <a:off x="673283" y="3686749"/>
            <a:ext cx="6785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20298A48-A789-4351-95E6-AB6C8A592BC5}"/>
              </a:ext>
            </a:extLst>
          </p:cNvPr>
          <p:cNvSpPr txBox="1"/>
          <p:nvPr/>
        </p:nvSpPr>
        <p:spPr>
          <a:xfrm>
            <a:off x="684713" y="4260225"/>
            <a:ext cx="6785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6B29D0C2-F4F8-4F90-82C0-277B351D46E7}"/>
              </a:ext>
            </a:extLst>
          </p:cNvPr>
          <p:cNvSpPr txBox="1"/>
          <p:nvPr/>
        </p:nvSpPr>
        <p:spPr>
          <a:xfrm>
            <a:off x="679489" y="4782750"/>
            <a:ext cx="6785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BB5FDCBC-8FAF-4DAF-BFB4-81A38BD80E23}"/>
              </a:ext>
            </a:extLst>
          </p:cNvPr>
          <p:cNvSpPr txBox="1"/>
          <p:nvPr/>
        </p:nvSpPr>
        <p:spPr>
          <a:xfrm>
            <a:off x="669711" y="4635401"/>
            <a:ext cx="6785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1F4922EB-6AD1-4921-BBF7-D373EE8DCD5E}"/>
              </a:ext>
            </a:extLst>
          </p:cNvPr>
          <p:cNvSpPr txBox="1"/>
          <p:nvPr/>
        </p:nvSpPr>
        <p:spPr>
          <a:xfrm>
            <a:off x="2208061" y="326437"/>
            <a:ext cx="1114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IP: Keap1</a:t>
            </a:r>
          </a:p>
        </p:txBody>
      </p:sp>
    </p:spTree>
    <p:extLst>
      <p:ext uri="{BB962C8B-B14F-4D97-AF65-F5344CB8AC3E}">
        <p14:creationId xmlns:p14="http://schemas.microsoft.com/office/powerpoint/2010/main" val="42324454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9FFFEAD3-2806-4113-B38A-78D5B6901D7F}"/>
              </a:ext>
            </a:extLst>
          </p:cNvPr>
          <p:cNvSpPr/>
          <p:nvPr/>
        </p:nvSpPr>
        <p:spPr>
          <a:xfrm>
            <a:off x="440090" y="-18299"/>
            <a:ext cx="505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4: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4C8C9F3-B622-4393-BAB4-33853F1FE35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957" t="8942" r="27063" b="32549"/>
          <a:stretch/>
        </p:blipFill>
        <p:spPr>
          <a:xfrm>
            <a:off x="1289538" y="997786"/>
            <a:ext cx="6067313" cy="4012602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06E4F594-C2A0-44B3-951B-A281803A8939}"/>
              </a:ext>
            </a:extLst>
          </p:cNvPr>
          <p:cNvSpPr/>
          <p:nvPr/>
        </p:nvSpPr>
        <p:spPr>
          <a:xfrm>
            <a:off x="440090" y="5275438"/>
            <a:ext cx="10152611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4: Un-modified Keap1 Co-IP blot. 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s stated in the materials and methods, co-immunoprecipitation was performed using the Abcam IP protocol and Nrf2 antibody bound to Protein G agarose beads.  After incubation with the lysate and washing, protein complexes were eluted from the beads for a total of two times using SDS buffer to produce two elution fractions.  For ease of data display, the main text Figure 3 shows just elution fraction 2, the whole cell lysate control (WCL), and the protein ladder (cropped from elution fraction 1 and designated as “mw” on the above blot).</a:t>
            </a:r>
            <a:endParaRPr lang="en-US" sz="14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0D0720E-37BE-4C86-91D7-733C8CBD2E23}"/>
              </a:ext>
            </a:extLst>
          </p:cNvPr>
          <p:cNvSpPr txBox="1"/>
          <p:nvPr/>
        </p:nvSpPr>
        <p:spPr>
          <a:xfrm>
            <a:off x="1682867" y="705584"/>
            <a:ext cx="5963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B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D5F0849-1F23-4DC4-AF3E-FC7AEE660AA3}"/>
              </a:ext>
            </a:extLst>
          </p:cNvPr>
          <p:cNvSpPr txBox="1"/>
          <p:nvPr/>
        </p:nvSpPr>
        <p:spPr>
          <a:xfrm>
            <a:off x="2038852" y="715466"/>
            <a:ext cx="5963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P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FB233C5-8864-4D43-8E3C-83BC3E93F1DD}"/>
              </a:ext>
            </a:extLst>
          </p:cNvPr>
          <p:cNvSpPr txBox="1"/>
          <p:nvPr/>
        </p:nvSpPr>
        <p:spPr>
          <a:xfrm>
            <a:off x="2420876" y="702097"/>
            <a:ext cx="5963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.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96F4A08-E070-409E-8A32-2514C19DAD39}"/>
              </a:ext>
            </a:extLst>
          </p:cNvPr>
          <p:cNvSpPr txBox="1"/>
          <p:nvPr/>
        </p:nvSpPr>
        <p:spPr>
          <a:xfrm>
            <a:off x="2816617" y="705583"/>
            <a:ext cx="5963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B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EE12420-B64B-44EA-BDAD-79652984DAEE}"/>
              </a:ext>
            </a:extLst>
          </p:cNvPr>
          <p:cNvSpPr txBox="1"/>
          <p:nvPr/>
        </p:nvSpPr>
        <p:spPr>
          <a:xfrm>
            <a:off x="3189316" y="715349"/>
            <a:ext cx="5963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P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DB5AF50-C02C-4AB2-808E-9EE1CA31E482}"/>
              </a:ext>
            </a:extLst>
          </p:cNvPr>
          <p:cNvSpPr txBox="1"/>
          <p:nvPr/>
        </p:nvSpPr>
        <p:spPr>
          <a:xfrm>
            <a:off x="3581817" y="703840"/>
            <a:ext cx="5963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.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BC5BA09-E507-441A-A683-8E2D2DB6199F}"/>
              </a:ext>
            </a:extLst>
          </p:cNvPr>
          <p:cNvSpPr txBox="1"/>
          <p:nvPr/>
        </p:nvSpPr>
        <p:spPr>
          <a:xfrm>
            <a:off x="3951276" y="715499"/>
            <a:ext cx="5963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BS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5DE68D9-E409-4DE9-81A6-A05113968F5A}"/>
              </a:ext>
            </a:extLst>
          </p:cNvPr>
          <p:cNvSpPr txBox="1"/>
          <p:nvPr/>
        </p:nvSpPr>
        <p:spPr>
          <a:xfrm>
            <a:off x="4290745" y="712129"/>
            <a:ext cx="5963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PS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1E36161-90E9-4370-9091-BA0913CE42A0}"/>
              </a:ext>
            </a:extLst>
          </p:cNvPr>
          <p:cNvSpPr txBox="1"/>
          <p:nvPr/>
        </p:nvSpPr>
        <p:spPr>
          <a:xfrm>
            <a:off x="1360601" y="696053"/>
            <a:ext cx="5963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w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7F27FE51-DAB3-4155-8422-89B5007798DA}"/>
              </a:ext>
            </a:extLst>
          </p:cNvPr>
          <p:cNvCxnSpPr>
            <a:cxnSpLocks/>
          </p:cNvCxnSpPr>
          <p:nvPr/>
        </p:nvCxnSpPr>
        <p:spPr>
          <a:xfrm>
            <a:off x="2860315" y="681352"/>
            <a:ext cx="110529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273FF8FD-A054-4799-9D4C-9B8C2317638F}"/>
              </a:ext>
            </a:extLst>
          </p:cNvPr>
          <p:cNvCxnSpPr>
            <a:cxnSpLocks/>
          </p:cNvCxnSpPr>
          <p:nvPr/>
        </p:nvCxnSpPr>
        <p:spPr>
          <a:xfrm>
            <a:off x="1711318" y="680217"/>
            <a:ext cx="110529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8106778A-52BC-4DE9-84D5-2C4F0EE07257}"/>
              </a:ext>
            </a:extLst>
          </p:cNvPr>
          <p:cNvCxnSpPr>
            <a:cxnSpLocks/>
          </p:cNvCxnSpPr>
          <p:nvPr/>
        </p:nvCxnSpPr>
        <p:spPr>
          <a:xfrm flipV="1">
            <a:off x="4026684" y="672037"/>
            <a:ext cx="562235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F8AE000A-8EA4-4B2B-A725-6917B06E94B3}"/>
              </a:ext>
            </a:extLst>
          </p:cNvPr>
          <p:cNvSpPr txBox="1"/>
          <p:nvPr/>
        </p:nvSpPr>
        <p:spPr>
          <a:xfrm>
            <a:off x="1879001" y="354816"/>
            <a:ext cx="8945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lution 1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4643277-9325-4373-A819-CA21042A7FBF}"/>
              </a:ext>
            </a:extLst>
          </p:cNvPr>
          <p:cNvSpPr txBox="1"/>
          <p:nvPr/>
        </p:nvSpPr>
        <p:spPr>
          <a:xfrm>
            <a:off x="3001785" y="352212"/>
            <a:ext cx="8945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lution 2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AF07AA1-B80F-4B4B-8D12-786073B34A63}"/>
              </a:ext>
            </a:extLst>
          </p:cNvPr>
          <p:cNvSpPr txBox="1"/>
          <p:nvPr/>
        </p:nvSpPr>
        <p:spPr>
          <a:xfrm>
            <a:off x="3882119" y="347115"/>
            <a:ext cx="8945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CL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CF632CBF-F7B0-498B-8FC8-AFA39585E249}"/>
              </a:ext>
            </a:extLst>
          </p:cNvPr>
          <p:cNvSpPr txBox="1"/>
          <p:nvPr/>
        </p:nvSpPr>
        <p:spPr>
          <a:xfrm>
            <a:off x="7317095" y="2305877"/>
            <a:ext cx="12570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IB: Keap1</a:t>
            </a:r>
          </a:p>
        </p:txBody>
      </p: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AC5862D1-DC73-4FE0-852C-D867D558554F}"/>
              </a:ext>
            </a:extLst>
          </p:cNvPr>
          <p:cNvCxnSpPr>
            <a:cxnSpLocks/>
          </p:cNvCxnSpPr>
          <p:nvPr/>
        </p:nvCxnSpPr>
        <p:spPr>
          <a:xfrm flipH="1">
            <a:off x="4903639" y="2477291"/>
            <a:ext cx="245321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6D9B844B-7A61-459B-9B72-D80284C2BA4C}"/>
              </a:ext>
            </a:extLst>
          </p:cNvPr>
          <p:cNvSpPr txBox="1"/>
          <p:nvPr/>
        </p:nvSpPr>
        <p:spPr>
          <a:xfrm>
            <a:off x="730675" y="2249025"/>
            <a:ext cx="6785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BF6C282-72DB-4E55-A21E-179139B3B365}"/>
              </a:ext>
            </a:extLst>
          </p:cNvPr>
          <p:cNvSpPr txBox="1"/>
          <p:nvPr/>
        </p:nvSpPr>
        <p:spPr>
          <a:xfrm>
            <a:off x="735129" y="2703159"/>
            <a:ext cx="6785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051DB67-0870-4E84-8DCF-34EDD353707C}"/>
              </a:ext>
            </a:extLst>
          </p:cNvPr>
          <p:cNvSpPr txBox="1"/>
          <p:nvPr/>
        </p:nvSpPr>
        <p:spPr>
          <a:xfrm>
            <a:off x="636104" y="2049281"/>
            <a:ext cx="7863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31EE895-5859-4738-8DDF-D76DE6BBC968}"/>
              </a:ext>
            </a:extLst>
          </p:cNvPr>
          <p:cNvSpPr txBox="1"/>
          <p:nvPr/>
        </p:nvSpPr>
        <p:spPr>
          <a:xfrm>
            <a:off x="636104" y="1841376"/>
            <a:ext cx="7863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0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5EA5A053-97EB-46A4-96B1-C109EC68E63C}"/>
              </a:ext>
            </a:extLst>
          </p:cNvPr>
          <p:cNvSpPr txBox="1"/>
          <p:nvPr/>
        </p:nvSpPr>
        <p:spPr>
          <a:xfrm>
            <a:off x="636104" y="1644531"/>
            <a:ext cx="7863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D8DC26BB-E774-4767-B941-7D9ADDD8CE85}"/>
              </a:ext>
            </a:extLst>
          </p:cNvPr>
          <p:cNvSpPr txBox="1"/>
          <p:nvPr/>
        </p:nvSpPr>
        <p:spPr>
          <a:xfrm>
            <a:off x="721876" y="3121223"/>
            <a:ext cx="6785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8FD38AD2-2989-41EC-BBA4-150B77947651}"/>
              </a:ext>
            </a:extLst>
          </p:cNvPr>
          <p:cNvSpPr txBox="1"/>
          <p:nvPr/>
        </p:nvSpPr>
        <p:spPr>
          <a:xfrm>
            <a:off x="730674" y="3734031"/>
            <a:ext cx="6785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1A0C5B26-1BBB-4666-BF80-26C382B9C39D}"/>
              </a:ext>
            </a:extLst>
          </p:cNvPr>
          <p:cNvSpPr txBox="1"/>
          <p:nvPr/>
        </p:nvSpPr>
        <p:spPr>
          <a:xfrm>
            <a:off x="2414626" y="63552"/>
            <a:ext cx="9476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IP: Nrf2</a:t>
            </a:r>
          </a:p>
        </p:txBody>
      </p:sp>
    </p:spTree>
    <p:extLst>
      <p:ext uri="{BB962C8B-B14F-4D97-AF65-F5344CB8AC3E}">
        <p14:creationId xmlns:p14="http://schemas.microsoft.com/office/powerpoint/2010/main" val="41363951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1</TotalTime>
  <Words>465</Words>
  <Application>Microsoft Office PowerPoint</Application>
  <PresentationFormat>Widescreen</PresentationFormat>
  <Paragraphs>53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ahtes and Li 2020 Polarization of low-grade inflammatory monocyte through TRAM -mediated upregulation of Keap1 by super-low dose endotoxin</dc:title>
  <dc:creator>Allison Rahtes</dc:creator>
  <cp:lastModifiedBy>Allison Rahtes</cp:lastModifiedBy>
  <cp:revision>10</cp:revision>
  <dcterms:created xsi:type="dcterms:W3CDTF">2020-03-20T19:31:53Z</dcterms:created>
  <dcterms:modified xsi:type="dcterms:W3CDTF">2020-06-30T20:00:33Z</dcterms:modified>
</cp:coreProperties>
</file>